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E0751D-ED99-437C-91F3-ACBA742A59B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2467E-6570-4D6E-8509-988CC56A3B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D7614F-AC02-494A-AB06-A6783CDA5A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9DDF73-416F-4600-A384-7D496B4470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02696-0A03-4238-AAB6-8DB32031DD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2E2AEB-8CB7-4307-9470-370808F5D0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65AB0-0A08-4D74-9BB4-AAA746F5AB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8A3D10-B02E-4EA3-B2BF-6A40CC2292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731D4-9EE7-4B29-827D-1CB3C6BFEB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C9AE10-372F-4EB1-998B-47E35C4981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81ACF-F394-4375-AFA9-1EB18B6942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53D4FF-9EB3-4636-9021-70DED1C17C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523880" y="6244920"/>
            <a:ext cx="60962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4E9866-DA1F-4E9D-B0C2-A248F576B87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83920" y="990720"/>
            <a:ext cx="744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dditional file 3. 8-mer-only Pairs where the Shorter Protein Contains 39 to 79 Amino Acid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609480" y="1828800"/>
            <a:ext cx="7002720" cy="332748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609480" y="5334120"/>
            <a:ext cx="7026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ach row contains information for pairs of sequences where the shorter sequence is from 39 to 79 amino acids in length and that share an identical 8-amino-acid stretch, but do not share &gt;35% homology over 80 amino acid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Rod Herman</cp:lastModifiedBy>
  <dcterms:modified xsi:type="dcterms:W3CDTF">2009-10-08T11:16:06Z</dcterms:modified>
  <cp:revision>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_Steward">
    <vt:lpwstr>Herman R u098402</vt:lpwstr>
  </property>
  <property fmtid="{D5CDD505-2E9C-101B-9397-08002B2CF9AE}" pid="3" name="Information_Classification">
    <vt:lpwstr>NONE</vt:lpwstr>
  </property>
  <property fmtid="{D5CDD505-2E9C-101B-9397-08002B2CF9AE}" pid="4" name="Initial_Creation_Date">
    <vt:lpwstr/>
  </property>
  <property fmtid="{D5CDD505-2E9C-101B-9397-08002B2CF9AE}" pid="5" name="Last_Reviewed_Date">
    <vt:lpwstr/>
  </property>
  <property fmtid="{D5CDD505-2E9C-101B-9397-08002B2CF9AE}" pid="6" name="Record_Title_ID">
    <vt:lpwstr>72</vt:lpwstr>
  </property>
  <property fmtid="{D5CDD505-2E9C-101B-9397-08002B2CF9AE}" pid="7" name="Retention_Period_Start_Date">
    <vt:lpwstr>8/19/2009</vt:lpwstr>
  </property>
  <property fmtid="{D5CDD505-2E9C-101B-9397-08002B2CF9AE}" pid="8" name="Retention_Review_Frequency">
    <vt:lpwstr/>
  </property>
  <property fmtid="{D5CDD505-2E9C-101B-9397-08002B2CF9AE}" pid="9" name="Version">
    <vt:r8>1</vt:r8>
  </property>
</Properties>
</file>